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6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574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370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04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24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45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700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293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33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571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823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636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E2C1A-0379-45F2-AC08-A164CBFA8A1A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17049-A85F-45F4-940C-C48914DEA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522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3" Type="http://schemas.openxmlformats.org/officeDocument/2006/relationships/image" Target="../media/image14.jpeg"/><Relationship Id="rId7" Type="http://schemas.openxmlformats.org/officeDocument/2006/relationships/image" Target="../media/image18.pn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eg"/><Relationship Id="rId11" Type="http://schemas.openxmlformats.org/officeDocument/2006/relationships/image" Target="../media/image22.jpeg"/><Relationship Id="rId5" Type="http://schemas.openxmlformats.org/officeDocument/2006/relationships/image" Target="../media/image16.jpeg"/><Relationship Id="rId10" Type="http://schemas.openxmlformats.org/officeDocument/2006/relationships/image" Target="../media/image21.jpeg"/><Relationship Id="rId4" Type="http://schemas.openxmlformats.org/officeDocument/2006/relationships/image" Target="../media/image15.jpeg"/><Relationship Id="rId9" Type="http://schemas.openxmlformats.org/officeDocument/2006/relationships/image" Target="../media/image2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21-4315 p504 20x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0038" y="387826"/>
            <a:ext cx="2551176" cy="1911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 descr="C:\Users\harrissr\AppData\Local\Microsoft\Windows\INetCache\Content.Word\21-4315 p504 Control 4x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4631" y="353862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 descr="E:\Prostate Sharon\2LNR OZ1 PSA control 20x.tif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88807" y="349879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Picture 13" descr="E:\Prostate Sharon\2LNV OVA p63 Control 20x.tif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9917" y="2336077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Picture 14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9479917" y="4318292"/>
            <a:ext cx="2551176" cy="1911096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135574" y="1266930"/>
            <a:ext cx="165203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MACR/P504</a:t>
            </a:r>
            <a:endParaRPr lang="en-US" sz="1050" b="1" dirty="0"/>
          </a:p>
        </p:txBody>
      </p:sp>
      <p:sp>
        <p:nvSpPr>
          <p:cNvPr id="19" name="Rectangle 18"/>
          <p:cNvSpPr/>
          <p:nvPr/>
        </p:nvSpPr>
        <p:spPr>
          <a:xfrm>
            <a:off x="608347" y="3271282"/>
            <a:ext cx="3898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R</a:t>
            </a:r>
            <a:endParaRPr lang="en-US" sz="1100" b="1" dirty="0"/>
          </a:p>
        </p:txBody>
      </p:sp>
      <p:sp>
        <p:nvSpPr>
          <p:cNvPr id="20" name="Rectangle 19"/>
          <p:cNvSpPr/>
          <p:nvPr/>
        </p:nvSpPr>
        <p:spPr>
          <a:xfrm>
            <a:off x="349008" y="5163355"/>
            <a:ext cx="67518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KX3.1</a:t>
            </a:r>
            <a:endParaRPr lang="en-US" sz="1100" b="1" dirty="0"/>
          </a:p>
        </p:txBody>
      </p:sp>
      <p:sp>
        <p:nvSpPr>
          <p:cNvPr id="21" name="Rectangle 20"/>
          <p:cNvSpPr/>
          <p:nvPr/>
        </p:nvSpPr>
        <p:spPr>
          <a:xfrm>
            <a:off x="6358185" y="1194942"/>
            <a:ext cx="45236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SA</a:t>
            </a:r>
            <a:endParaRPr lang="en-US" sz="1100" b="1" dirty="0"/>
          </a:p>
        </p:txBody>
      </p:sp>
      <p:sp>
        <p:nvSpPr>
          <p:cNvPr id="22" name="Rectangle 21"/>
          <p:cNvSpPr/>
          <p:nvPr/>
        </p:nvSpPr>
        <p:spPr>
          <a:xfrm>
            <a:off x="6345807" y="3402087"/>
            <a:ext cx="41229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63</a:t>
            </a:r>
            <a:endParaRPr lang="en-US" sz="1100" b="1" dirty="0"/>
          </a:p>
        </p:txBody>
      </p:sp>
      <p:sp>
        <p:nvSpPr>
          <p:cNvPr id="24" name="Rectangle 23"/>
          <p:cNvSpPr/>
          <p:nvPr/>
        </p:nvSpPr>
        <p:spPr>
          <a:xfrm>
            <a:off x="6280439" y="5163355"/>
            <a:ext cx="6078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GA</a:t>
            </a:r>
            <a:endParaRPr lang="en-US" sz="11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7517013" y="17034"/>
            <a:ext cx="2343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CRJ-PC28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0229096" y="-15495"/>
            <a:ext cx="2343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ositive control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581302" y="52594"/>
            <a:ext cx="2343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CRJ-PC28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915156" y="17034"/>
            <a:ext cx="2343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ositive control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082548" y="2336077"/>
            <a:ext cx="2551176" cy="1911096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100038" y="4321484"/>
            <a:ext cx="2551176" cy="1911096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808330" y="4348063"/>
            <a:ext cx="2912099" cy="191431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818481" y="2329269"/>
            <a:ext cx="2901948" cy="1914310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806288" y="339453"/>
            <a:ext cx="2914141" cy="1914310"/>
          </a:xfrm>
          <a:prstGeom prst="rect">
            <a:avLst/>
          </a:prstGeom>
        </p:spPr>
      </p:pic>
      <p:grpSp>
        <p:nvGrpSpPr>
          <p:cNvPr id="44" name="Group 43"/>
          <p:cNvGrpSpPr/>
          <p:nvPr/>
        </p:nvGrpSpPr>
        <p:grpSpPr>
          <a:xfrm>
            <a:off x="11735215" y="6081654"/>
            <a:ext cx="261998" cy="45719"/>
            <a:chOff x="8048625" y="6494783"/>
            <a:chExt cx="519396" cy="58269"/>
          </a:xfrm>
        </p:grpSpPr>
        <p:cxnSp>
          <p:nvCxnSpPr>
            <p:cNvPr id="45" name="Straight Connector 44"/>
            <p:cNvCxnSpPr/>
            <p:nvPr/>
          </p:nvCxnSpPr>
          <p:spPr>
            <a:xfrm>
              <a:off x="8056238" y="6523917"/>
              <a:ext cx="503705" cy="49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8061561" y="6517341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 flipV="1">
              <a:off x="8568020" y="6494783"/>
              <a:ext cx="1" cy="582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 flipV="1">
              <a:off x="8048625" y="6494783"/>
              <a:ext cx="1" cy="582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TextBox 48"/>
          <p:cNvSpPr txBox="1"/>
          <p:nvPr/>
        </p:nvSpPr>
        <p:spPr>
          <a:xfrm>
            <a:off x="11672185" y="5968882"/>
            <a:ext cx="6419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100 µm</a:t>
            </a:r>
          </a:p>
        </p:txBody>
      </p:sp>
      <p:grpSp>
        <p:nvGrpSpPr>
          <p:cNvPr id="50" name="Group 49"/>
          <p:cNvGrpSpPr/>
          <p:nvPr/>
        </p:nvGrpSpPr>
        <p:grpSpPr>
          <a:xfrm>
            <a:off x="11613125" y="4170558"/>
            <a:ext cx="261998" cy="45719"/>
            <a:chOff x="8048625" y="6494783"/>
            <a:chExt cx="519396" cy="58269"/>
          </a:xfrm>
        </p:grpSpPr>
        <p:cxnSp>
          <p:nvCxnSpPr>
            <p:cNvPr id="53" name="Straight Connector 52"/>
            <p:cNvCxnSpPr/>
            <p:nvPr/>
          </p:nvCxnSpPr>
          <p:spPr>
            <a:xfrm>
              <a:off x="8056238" y="6523917"/>
              <a:ext cx="503705" cy="49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8061561" y="6517341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V="1">
              <a:off x="8568020" y="6494783"/>
              <a:ext cx="1" cy="582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V="1">
              <a:off x="8048625" y="6494783"/>
              <a:ext cx="1" cy="582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/>
          <p:cNvSpPr txBox="1"/>
          <p:nvPr/>
        </p:nvSpPr>
        <p:spPr>
          <a:xfrm>
            <a:off x="11550095" y="4057786"/>
            <a:ext cx="6419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100 µm</a:t>
            </a:r>
          </a:p>
        </p:txBody>
      </p:sp>
      <p:grpSp>
        <p:nvGrpSpPr>
          <p:cNvPr id="58" name="Group 57"/>
          <p:cNvGrpSpPr/>
          <p:nvPr/>
        </p:nvGrpSpPr>
        <p:grpSpPr>
          <a:xfrm>
            <a:off x="11541186" y="2139416"/>
            <a:ext cx="261998" cy="45719"/>
            <a:chOff x="8048625" y="6494783"/>
            <a:chExt cx="519396" cy="58269"/>
          </a:xfrm>
        </p:grpSpPr>
        <p:cxnSp>
          <p:nvCxnSpPr>
            <p:cNvPr id="59" name="Straight Connector 58"/>
            <p:cNvCxnSpPr/>
            <p:nvPr/>
          </p:nvCxnSpPr>
          <p:spPr>
            <a:xfrm>
              <a:off x="8056238" y="6523917"/>
              <a:ext cx="503705" cy="49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8061561" y="6517341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 flipV="1">
              <a:off x="8568020" y="6494783"/>
              <a:ext cx="1" cy="582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 flipV="1">
              <a:off x="8048625" y="6494783"/>
              <a:ext cx="1" cy="582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3" name="TextBox 62"/>
          <p:cNvSpPr txBox="1"/>
          <p:nvPr/>
        </p:nvSpPr>
        <p:spPr>
          <a:xfrm>
            <a:off x="11478156" y="2026644"/>
            <a:ext cx="6419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100 µm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794631" y="2336077"/>
            <a:ext cx="3377477" cy="191431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793818" y="4325893"/>
            <a:ext cx="3377477" cy="19143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3649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:\Users\harrissr\AppData\Local\Microsoft\Windows\INetCache\Content.Word\21-4315 Synapto Negative 20x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205" y="684819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2" descr="21-4315 Synapto Control 4x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1486" y="684819"/>
            <a:ext cx="2551176" cy="1911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Rectangle 7"/>
          <p:cNvSpPr/>
          <p:nvPr/>
        </p:nvSpPr>
        <p:spPr>
          <a:xfrm>
            <a:off x="152707" y="1550774"/>
            <a:ext cx="45236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YP</a:t>
            </a:r>
            <a:endParaRPr lang="en-US" sz="1100" b="1" dirty="0"/>
          </a:p>
        </p:txBody>
      </p:sp>
      <p:pic>
        <p:nvPicPr>
          <p:cNvPr id="9" name="Picture 8" descr="C:\Users\harrissr\AppData\Local\Microsoft\Windows\INetCache\Content.Word\21-4315 Ki67 20x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216" y="2673168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 descr="C:\Users\harrissr\AppData\Local\Microsoft\Windows\INetCache\Content.Word\21-4315 Ki67 Control 4x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4723" y="2673168"/>
            <a:ext cx="2551176" cy="1911096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/>
          <p:cNvSpPr/>
          <p:nvPr/>
        </p:nvSpPr>
        <p:spPr>
          <a:xfrm>
            <a:off x="113059" y="3497911"/>
            <a:ext cx="44114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i67</a:t>
            </a:r>
            <a:endParaRPr lang="en-US" b="1" dirty="0"/>
          </a:p>
        </p:txBody>
      </p:sp>
      <p:pic>
        <p:nvPicPr>
          <p:cNvPr id="13" name="Picture 12" descr="C:\Users\harrissr\AppData\Local\Microsoft\Windows\INetCache\Content.Word\21-4315 CD44 20x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216" y="4740641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Picture 13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4723" y="4740641"/>
            <a:ext cx="2551176" cy="1911096"/>
          </a:xfrm>
          <a:prstGeom prst="rect">
            <a:avLst/>
          </a:prstGeom>
          <a:noFill/>
        </p:spPr>
      </p:pic>
      <p:sp>
        <p:nvSpPr>
          <p:cNvPr id="11" name="Rectangle 10"/>
          <p:cNvSpPr/>
          <p:nvPr/>
        </p:nvSpPr>
        <p:spPr>
          <a:xfrm>
            <a:off x="113059" y="5696189"/>
            <a:ext cx="49244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4</a:t>
            </a:r>
            <a:endParaRPr lang="en-US" sz="1600" b="1" dirty="0"/>
          </a:p>
        </p:txBody>
      </p:sp>
      <p:pic>
        <p:nvPicPr>
          <p:cNvPr id="2052" name="Picture 4" descr="21-4315 c-MYC 20x Positive"/>
          <p:cNvPicPr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9870" y="684819"/>
            <a:ext cx="2551176" cy="1911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16" descr="C:\Users\harrissr\AppData\Local\Microsoft\Windows\INetCache\Content.Word\21-4315 c-MYC Control 4x.jpg"/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89012" y="684819"/>
            <a:ext cx="2551176" cy="1911096"/>
          </a:xfrm>
          <a:prstGeom prst="rect">
            <a:avLst/>
          </a:prstGeom>
          <a:noFill/>
          <a:ln>
            <a:noFill/>
          </a:ln>
        </p:spPr>
      </p:pic>
      <p:sp>
        <p:nvSpPr>
          <p:cNvPr id="20" name="Rectangle 19"/>
          <p:cNvSpPr/>
          <p:nvPr/>
        </p:nvSpPr>
        <p:spPr>
          <a:xfrm>
            <a:off x="6072694" y="1509562"/>
            <a:ext cx="4571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Calibri" panose="020F0502020204030204" pitchFamily="34" charset="0"/>
                <a:cs typeface="Times New Roman" panose="02020603050405020304" pitchFamily="18" charset="0"/>
              </a:rPr>
              <a:t>MYC</a:t>
            </a:r>
            <a:endParaRPr lang="en-US" b="1" dirty="0"/>
          </a:p>
        </p:txBody>
      </p:sp>
      <p:pic>
        <p:nvPicPr>
          <p:cNvPr id="22" name="Picture 21" descr="C:\Users\harrissr\AppData\Local\Microsoft\Windows\INetCache\Content.Word\21-4315 MUC1 20x.jpg"/>
          <p:cNvPicPr/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9870" y="2673168"/>
            <a:ext cx="2551176" cy="1911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Picture 22" descr="C:\Users\harrissr\AppData\Local\Microsoft\Windows\INetCache\Content.Word\21-4315 MUC1 Control 4x.jpg"/>
          <p:cNvPicPr/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89012" y="2673168"/>
            <a:ext cx="2551176" cy="1911096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Rectangle 11"/>
          <p:cNvSpPr/>
          <p:nvPr/>
        </p:nvSpPr>
        <p:spPr>
          <a:xfrm>
            <a:off x="6033046" y="3426749"/>
            <a:ext cx="51167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CI</a:t>
            </a:r>
            <a:endParaRPr lang="en-US" sz="16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554205" y="144815"/>
            <a:ext cx="2343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CRJ-PC28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018382" y="180375"/>
            <a:ext cx="2343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ositive control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247993" y="180375"/>
            <a:ext cx="2343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CRJ-PC28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9901404" y="178452"/>
            <a:ext cx="2343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ositive control</a:t>
            </a:r>
          </a:p>
        </p:txBody>
      </p:sp>
      <p:sp>
        <p:nvSpPr>
          <p:cNvPr id="2" name="Rectangle 1"/>
          <p:cNvSpPr/>
          <p:nvPr/>
        </p:nvSpPr>
        <p:spPr>
          <a:xfrm>
            <a:off x="6033046" y="4955199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l Figure 3: 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HC staining on ACRJ-PC28 cells compared to positive controls.</a:t>
            </a:r>
            <a:endParaRPr lang="en-US" sz="16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2367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44</TotalTime>
  <Words>45</Words>
  <Application>Microsoft Macintosh PowerPoint</Application>
  <PresentationFormat>Widescreen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e, Henkel L</dc:creator>
  <cp:lastModifiedBy>Simone Badal</cp:lastModifiedBy>
  <cp:revision>26</cp:revision>
  <dcterms:created xsi:type="dcterms:W3CDTF">2022-05-12T18:42:08Z</dcterms:created>
  <dcterms:modified xsi:type="dcterms:W3CDTF">2022-06-23T13:49:39Z</dcterms:modified>
</cp:coreProperties>
</file>